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10"/>
  </p:notesMasterIdLst>
  <p:sldIdLst>
    <p:sldId id="275" r:id="rId5"/>
    <p:sldId id="1747" r:id="rId6"/>
    <p:sldId id="1741" r:id="rId7"/>
    <p:sldId id="1746" r:id="rId8"/>
    <p:sldId id="1745" r:id="rId9"/>
  </p:sldIdLst>
  <p:sldSz cx="6858000" cy="9144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0D24E08-3C48-7065-A27A-7A5167B66E65}" name="Gauthier Dangla-Pelissier" initials="GD" userId="S::gauthier.dangla@vect-horus.com::1c162ed9-8cd3-43f0-b27d-f8d05ace784e" providerId="AD"/>
  <p188:author id="{C261851D-D4F4-170D-1012-218DF0CE0DE5}" name="Marion DAVID" initials="MD" userId="S::marion.david@vect-horus.com::ad3bef0d-db02-4846-8332-f783a325953c" providerId="AD"/>
  <p188:author id="{D1AC4351-87D7-EBBD-E858-B89FDD43FE6C}" name="Romy COHEN" initials="RC" userId="S::romy.cohen@vect-horus.com::912a5209-6f96-46f6-810f-2602e46d7420" providerId="AD"/>
  <p188:author id="{FFEEBF9E-C97A-02BC-48DA-091FB4C81357}" name="Marion DAVID" initials="MD" userId="Marion DAVID" providerId="None"/>
  <p188:author id="{626904B5-6D5B-586C-EA1A-1C6398576941}" name="Diane BEUZELIN" initials="DB" userId="S::diane.beuzelin@vect-horus.com::cff1e025-08d8-4ca7-8295-e54b014631f7" providerId="AD"/>
  <p188:author id="{237AC2CF-6F3E-9144-ECBE-55C9AC61DA8A}" name="Gersande GODEFROY" initials="GG" userId="S::gersande.godefroy@vect-horus.com::37084baa-9bcb-40e4-80ae-2940ac5fbade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ion" initials="MD" lastIdx="12" clrIdx="0">
    <p:extLst>
      <p:ext uri="{19B8F6BF-5375-455C-9EA6-DF929625EA0E}">
        <p15:presenceInfo xmlns:p15="http://schemas.microsoft.com/office/powerpoint/2012/main" userId="Marion" providerId="None"/>
      </p:ext>
    </p:extLst>
  </p:cmAuthor>
  <p:cmAuthor id="2" name="Romy Cohen" initials="RC" lastIdx="1" clrIdx="1">
    <p:extLst>
      <p:ext uri="{19B8F6BF-5375-455C-9EA6-DF929625EA0E}">
        <p15:presenceInfo xmlns:p15="http://schemas.microsoft.com/office/powerpoint/2012/main" userId="e870efe83cb44aca" providerId="Windows Live"/>
      </p:ext>
    </p:extLst>
  </p:cmAuthor>
  <p:cmAuthor id="3" name="Romy" initials="R" lastIdx="2" clrIdx="2">
    <p:extLst>
      <p:ext uri="{19B8F6BF-5375-455C-9EA6-DF929625EA0E}">
        <p15:presenceInfo xmlns:p15="http://schemas.microsoft.com/office/powerpoint/2012/main" userId="Romy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517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A57DFD8-AA43-4324-827A-B828CD0FF59A}" v="16" dt="2025-05-08T06:30:43.90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46"/>
  </p:normalViewPr>
  <p:slideViewPr>
    <p:cSldViewPr snapToGrid="0">
      <p:cViewPr varScale="1">
        <p:scale>
          <a:sx n="78" d="100"/>
          <a:sy n="78" d="100"/>
        </p:scale>
        <p:origin x="3608" y="16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18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commentAuthors" Target="commentAuthors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on DAVID" userId="ad3bef0d-db02-4846-8332-f783a325953c" providerId="ADAL" clId="{DA57DFD8-AA43-4324-827A-B828CD0FF59A}"/>
    <pc:docChg chg="custSel delSld modSld">
      <pc:chgData name="Marion DAVID" userId="ad3bef0d-db02-4846-8332-f783a325953c" providerId="ADAL" clId="{DA57DFD8-AA43-4324-827A-B828CD0FF59A}" dt="2025-05-08T06:30:46.739" v="77" actId="1035"/>
      <pc:docMkLst>
        <pc:docMk/>
      </pc:docMkLst>
      <pc:sldChg chg="del">
        <pc:chgData name="Marion DAVID" userId="ad3bef0d-db02-4846-8332-f783a325953c" providerId="ADAL" clId="{DA57DFD8-AA43-4324-827A-B828CD0FF59A}" dt="2025-05-08T06:26:12.713" v="2" actId="47"/>
        <pc:sldMkLst>
          <pc:docMk/>
          <pc:sldMk cId="2521384167" sldId="265"/>
        </pc:sldMkLst>
      </pc:sldChg>
      <pc:sldChg chg="del">
        <pc:chgData name="Marion DAVID" userId="ad3bef0d-db02-4846-8332-f783a325953c" providerId="ADAL" clId="{DA57DFD8-AA43-4324-827A-B828CD0FF59A}" dt="2025-05-08T06:26:16.049" v="4" actId="47"/>
        <pc:sldMkLst>
          <pc:docMk/>
          <pc:sldMk cId="348047053" sldId="269"/>
        </pc:sldMkLst>
      </pc:sldChg>
      <pc:sldChg chg="addSp delSp modSp mod">
        <pc:chgData name="Marion DAVID" userId="ad3bef0d-db02-4846-8332-f783a325953c" providerId="ADAL" clId="{DA57DFD8-AA43-4324-827A-B828CD0FF59A}" dt="2025-05-08T06:28:39.489" v="13" actId="1076"/>
        <pc:sldMkLst>
          <pc:docMk/>
          <pc:sldMk cId="2873866887" sldId="275"/>
        </pc:sldMkLst>
        <pc:spChg chg="mod">
          <ac:chgData name="Marion DAVID" userId="ad3bef0d-db02-4846-8332-f783a325953c" providerId="ADAL" clId="{DA57DFD8-AA43-4324-827A-B828CD0FF59A}" dt="2025-05-08T06:28:21.724" v="9" actId="164"/>
          <ac:spMkLst>
            <pc:docMk/>
            <pc:sldMk cId="2873866887" sldId="275"/>
            <ac:spMk id="4" creationId="{C889396E-2A7B-C338-840A-12FD7CE9232F}"/>
          </ac:spMkLst>
        </pc:spChg>
        <pc:spChg chg="mod">
          <ac:chgData name="Marion DAVID" userId="ad3bef0d-db02-4846-8332-f783a325953c" providerId="ADAL" clId="{DA57DFD8-AA43-4324-827A-B828CD0FF59A}" dt="2025-05-08T06:28:21.724" v="9" actId="164"/>
          <ac:spMkLst>
            <pc:docMk/>
            <pc:sldMk cId="2873866887" sldId="275"/>
            <ac:spMk id="8" creationId="{D63E077B-EAA6-618C-8251-3840D9BC71CE}"/>
          </ac:spMkLst>
        </pc:spChg>
        <pc:spChg chg="mod">
          <ac:chgData name="Marion DAVID" userId="ad3bef0d-db02-4846-8332-f783a325953c" providerId="ADAL" clId="{DA57DFD8-AA43-4324-827A-B828CD0FF59A}" dt="2025-05-08T06:28:28.050" v="11"/>
          <ac:spMkLst>
            <pc:docMk/>
            <pc:sldMk cId="2873866887" sldId="275"/>
            <ac:spMk id="54" creationId="{C0C88398-123B-4337-823E-B90FDE8E1E42}"/>
          </ac:spMkLst>
        </pc:spChg>
        <pc:spChg chg="mod">
          <ac:chgData name="Marion DAVID" userId="ad3bef0d-db02-4846-8332-f783a325953c" providerId="ADAL" clId="{DA57DFD8-AA43-4324-827A-B828CD0FF59A}" dt="2025-05-08T06:28:28.050" v="11"/>
          <ac:spMkLst>
            <pc:docMk/>
            <pc:sldMk cId="2873866887" sldId="275"/>
            <ac:spMk id="57" creationId="{40908707-4AB3-4253-8803-32CDCBBC66B9}"/>
          </ac:spMkLst>
        </pc:spChg>
        <pc:spChg chg="mod">
          <ac:chgData name="Marion DAVID" userId="ad3bef0d-db02-4846-8332-f783a325953c" providerId="ADAL" clId="{DA57DFD8-AA43-4324-827A-B828CD0FF59A}" dt="2025-05-08T06:28:21.724" v="9" actId="164"/>
          <ac:spMkLst>
            <pc:docMk/>
            <pc:sldMk cId="2873866887" sldId="275"/>
            <ac:spMk id="63" creationId="{C0C88398-123B-4337-823E-B90FDE8E1E42}"/>
          </ac:spMkLst>
        </pc:spChg>
        <pc:spChg chg="mod">
          <ac:chgData name="Marion DAVID" userId="ad3bef0d-db02-4846-8332-f783a325953c" providerId="ADAL" clId="{DA57DFD8-AA43-4324-827A-B828CD0FF59A}" dt="2025-05-08T06:28:21.724" v="9" actId="164"/>
          <ac:spMkLst>
            <pc:docMk/>
            <pc:sldMk cId="2873866887" sldId="275"/>
            <ac:spMk id="64" creationId="{40908707-4AB3-4253-8803-32CDCBBC66B9}"/>
          </ac:spMkLst>
        </pc:spChg>
        <pc:spChg chg="mod">
          <ac:chgData name="Marion DAVID" userId="ad3bef0d-db02-4846-8332-f783a325953c" providerId="ADAL" clId="{DA57DFD8-AA43-4324-827A-B828CD0FF59A}" dt="2025-05-08T06:28:21.724" v="9" actId="164"/>
          <ac:spMkLst>
            <pc:docMk/>
            <pc:sldMk cId="2873866887" sldId="275"/>
            <ac:spMk id="65" creationId="{81899EF5-4910-4704-91BE-A201029817EA}"/>
          </ac:spMkLst>
        </pc:spChg>
        <pc:spChg chg="mod">
          <ac:chgData name="Marion DAVID" userId="ad3bef0d-db02-4846-8332-f783a325953c" providerId="ADAL" clId="{DA57DFD8-AA43-4324-827A-B828CD0FF59A}" dt="2025-05-08T06:28:28.050" v="11"/>
          <ac:spMkLst>
            <pc:docMk/>
            <pc:sldMk cId="2873866887" sldId="275"/>
            <ac:spMk id="71" creationId="{30EEA1E4-C77E-5C80-2D00-49EB2FDEDD21}"/>
          </ac:spMkLst>
        </pc:spChg>
        <pc:spChg chg="mod">
          <ac:chgData name="Marion DAVID" userId="ad3bef0d-db02-4846-8332-f783a325953c" providerId="ADAL" clId="{DA57DFD8-AA43-4324-827A-B828CD0FF59A}" dt="2025-05-08T06:28:28.050" v="11"/>
          <ac:spMkLst>
            <pc:docMk/>
            <pc:sldMk cId="2873866887" sldId="275"/>
            <ac:spMk id="72" creationId="{8D04EAAC-7F07-5584-87F4-308328C05EC9}"/>
          </ac:spMkLst>
        </pc:spChg>
        <pc:spChg chg="mod">
          <ac:chgData name="Marion DAVID" userId="ad3bef0d-db02-4846-8332-f783a325953c" providerId="ADAL" clId="{DA57DFD8-AA43-4324-827A-B828CD0FF59A}" dt="2025-05-08T06:28:28.050" v="11"/>
          <ac:spMkLst>
            <pc:docMk/>
            <pc:sldMk cId="2873866887" sldId="275"/>
            <ac:spMk id="77" creationId="{FF69F3C3-7593-641D-84F0-36A2E5942253}"/>
          </ac:spMkLst>
        </pc:spChg>
        <pc:spChg chg="mod">
          <ac:chgData name="Marion DAVID" userId="ad3bef0d-db02-4846-8332-f783a325953c" providerId="ADAL" clId="{DA57DFD8-AA43-4324-827A-B828CD0FF59A}" dt="2025-05-08T06:28:28.050" v="11"/>
          <ac:spMkLst>
            <pc:docMk/>
            <pc:sldMk cId="2873866887" sldId="275"/>
            <ac:spMk id="84" creationId="{FB09B09C-0D88-93EA-25A3-4CCCACB69A8C}"/>
          </ac:spMkLst>
        </pc:spChg>
        <pc:spChg chg="mod">
          <ac:chgData name="Marion DAVID" userId="ad3bef0d-db02-4846-8332-f783a325953c" providerId="ADAL" clId="{DA57DFD8-AA43-4324-827A-B828CD0FF59A}" dt="2025-05-08T06:28:28.050" v="11"/>
          <ac:spMkLst>
            <pc:docMk/>
            <pc:sldMk cId="2873866887" sldId="275"/>
            <ac:spMk id="87" creationId="{F14CC494-3765-EC69-C7F5-4A8380E24B00}"/>
          </ac:spMkLst>
        </pc:spChg>
        <pc:spChg chg="mod">
          <ac:chgData name="Marion DAVID" userId="ad3bef0d-db02-4846-8332-f783a325953c" providerId="ADAL" clId="{DA57DFD8-AA43-4324-827A-B828CD0FF59A}" dt="2025-05-08T06:28:28.050" v="11"/>
          <ac:spMkLst>
            <pc:docMk/>
            <pc:sldMk cId="2873866887" sldId="275"/>
            <ac:spMk id="88" creationId="{211772E3-BD76-1A35-CB1F-9659D1C29CD0}"/>
          </ac:spMkLst>
        </pc:spChg>
        <pc:spChg chg="mod">
          <ac:chgData name="Marion DAVID" userId="ad3bef0d-db02-4846-8332-f783a325953c" providerId="ADAL" clId="{DA57DFD8-AA43-4324-827A-B828CD0FF59A}" dt="2025-05-08T06:28:28.050" v="11"/>
          <ac:spMkLst>
            <pc:docMk/>
            <pc:sldMk cId="2873866887" sldId="275"/>
            <ac:spMk id="89" creationId="{10320592-A9B3-3C6E-EF10-9E2FD31FC76F}"/>
          </ac:spMkLst>
        </pc:spChg>
        <pc:spChg chg="mod">
          <ac:chgData name="Marion DAVID" userId="ad3bef0d-db02-4846-8332-f783a325953c" providerId="ADAL" clId="{DA57DFD8-AA43-4324-827A-B828CD0FF59A}" dt="2025-05-08T06:28:28.050" v="11"/>
          <ac:spMkLst>
            <pc:docMk/>
            <pc:sldMk cId="2873866887" sldId="275"/>
            <ac:spMk id="112" creationId="{A34C3856-94B0-4583-AA4F-65ABEC1C2D2D}"/>
          </ac:spMkLst>
        </pc:spChg>
        <pc:grpChg chg="mod">
          <ac:chgData name="Marion DAVID" userId="ad3bef0d-db02-4846-8332-f783a325953c" providerId="ADAL" clId="{DA57DFD8-AA43-4324-827A-B828CD0FF59A}" dt="2025-05-08T06:28:21.724" v="9" actId="164"/>
          <ac:grpSpMkLst>
            <pc:docMk/>
            <pc:sldMk cId="2873866887" sldId="275"/>
            <ac:grpSpMk id="3" creationId="{C3025C83-4970-4CF6-96B1-9A968E04817C}"/>
          </ac:grpSpMkLst>
        </pc:grpChg>
        <pc:grpChg chg="mod">
          <ac:chgData name="Marion DAVID" userId="ad3bef0d-db02-4846-8332-f783a325953c" providerId="ADAL" clId="{DA57DFD8-AA43-4324-827A-B828CD0FF59A}" dt="2025-05-08T06:28:21.724" v="9" actId="164"/>
          <ac:grpSpMkLst>
            <pc:docMk/>
            <pc:sldMk cId="2873866887" sldId="275"/>
            <ac:grpSpMk id="6" creationId="{0F179ED7-9FBC-4580-854D-4F9E76A70D44}"/>
          </ac:grpSpMkLst>
        </pc:grpChg>
        <pc:grpChg chg="del">
          <ac:chgData name="Marion DAVID" userId="ad3bef0d-db02-4846-8332-f783a325953c" providerId="ADAL" clId="{DA57DFD8-AA43-4324-827A-B828CD0FF59A}" dt="2025-05-08T06:28:26.790" v="10" actId="21"/>
          <ac:grpSpMkLst>
            <pc:docMk/>
            <pc:sldMk cId="2873866887" sldId="275"/>
            <ac:grpSpMk id="9" creationId="{35111E02-A770-8719-AEAF-9BD2EBFCFF94}"/>
          </ac:grpSpMkLst>
        </pc:grpChg>
        <pc:picChg chg="mod">
          <ac:chgData name="Marion DAVID" userId="ad3bef0d-db02-4846-8332-f783a325953c" providerId="ADAL" clId="{DA57DFD8-AA43-4324-827A-B828CD0FF59A}" dt="2025-05-08T06:28:21.724" v="9" actId="164"/>
          <ac:picMkLst>
            <pc:docMk/>
            <pc:sldMk cId="2873866887" sldId="275"/>
            <ac:picMk id="10" creationId="{00000000-0000-0000-0000-000000000000}"/>
          </ac:picMkLst>
        </pc:picChg>
        <pc:picChg chg="mod">
          <ac:chgData name="Marion DAVID" userId="ad3bef0d-db02-4846-8332-f783a325953c" providerId="ADAL" clId="{DA57DFD8-AA43-4324-827A-B828CD0FF59A}" dt="2025-05-08T06:28:21.724" v="9" actId="164"/>
          <ac:picMkLst>
            <pc:docMk/>
            <pc:sldMk cId="2873866887" sldId="275"/>
            <ac:picMk id="55" creationId="{00000000-0000-0000-0000-000000000000}"/>
          </ac:picMkLst>
        </pc:picChg>
        <pc:picChg chg="mod">
          <ac:chgData name="Marion DAVID" userId="ad3bef0d-db02-4846-8332-f783a325953c" providerId="ADAL" clId="{DA57DFD8-AA43-4324-827A-B828CD0FF59A}" dt="2025-05-08T06:28:21.724" v="9" actId="164"/>
          <ac:picMkLst>
            <pc:docMk/>
            <pc:sldMk cId="2873866887" sldId="275"/>
            <ac:picMk id="56" creationId="{00000000-0000-0000-0000-000000000000}"/>
          </ac:picMkLst>
        </pc:picChg>
        <pc:picChg chg="add mod">
          <ac:chgData name="Marion DAVID" userId="ad3bef0d-db02-4846-8332-f783a325953c" providerId="ADAL" clId="{DA57DFD8-AA43-4324-827A-B828CD0FF59A}" dt="2025-05-08T06:28:39.489" v="13" actId="1076"/>
          <ac:picMkLst>
            <pc:docMk/>
            <pc:sldMk cId="2873866887" sldId="275"/>
            <ac:picMk id="118" creationId="{C3038C88-283B-6D87-1821-0EFBD5C4D312}"/>
          </ac:picMkLst>
        </pc:picChg>
      </pc:sldChg>
      <pc:sldChg chg="del">
        <pc:chgData name="Marion DAVID" userId="ad3bef0d-db02-4846-8332-f783a325953c" providerId="ADAL" clId="{DA57DFD8-AA43-4324-827A-B828CD0FF59A}" dt="2025-05-08T06:26:18.234" v="6" actId="47"/>
        <pc:sldMkLst>
          <pc:docMk/>
          <pc:sldMk cId="437507071" sldId="1733"/>
        </pc:sldMkLst>
      </pc:sldChg>
      <pc:sldChg chg="del">
        <pc:chgData name="Marion DAVID" userId="ad3bef0d-db02-4846-8332-f783a325953c" providerId="ADAL" clId="{DA57DFD8-AA43-4324-827A-B828CD0FF59A}" dt="2025-05-08T06:26:17.572" v="5" actId="47"/>
        <pc:sldMkLst>
          <pc:docMk/>
          <pc:sldMk cId="2067609666" sldId="1734"/>
        </pc:sldMkLst>
      </pc:sldChg>
      <pc:sldChg chg="del">
        <pc:chgData name="Marion DAVID" userId="ad3bef0d-db02-4846-8332-f783a325953c" providerId="ADAL" clId="{DA57DFD8-AA43-4324-827A-B828CD0FF59A}" dt="2025-05-08T06:26:11.109" v="0" actId="47"/>
        <pc:sldMkLst>
          <pc:docMk/>
          <pc:sldMk cId="4164026718" sldId="1737"/>
        </pc:sldMkLst>
      </pc:sldChg>
      <pc:sldChg chg="del">
        <pc:chgData name="Marion DAVID" userId="ad3bef0d-db02-4846-8332-f783a325953c" providerId="ADAL" clId="{DA57DFD8-AA43-4324-827A-B828CD0FF59A}" dt="2025-05-08T06:26:19.776" v="8" actId="47"/>
        <pc:sldMkLst>
          <pc:docMk/>
          <pc:sldMk cId="1676947728" sldId="1739"/>
        </pc:sldMkLst>
      </pc:sldChg>
      <pc:sldChg chg="addSp delSp modSp mod">
        <pc:chgData name="Marion DAVID" userId="ad3bef0d-db02-4846-8332-f783a325953c" providerId="ADAL" clId="{DA57DFD8-AA43-4324-827A-B828CD0FF59A}" dt="2025-05-08T06:29:14.038" v="53" actId="1035"/>
        <pc:sldMkLst>
          <pc:docMk/>
          <pc:sldMk cId="2356615034" sldId="1741"/>
        </pc:sldMkLst>
        <pc:spChg chg="mod">
          <ac:chgData name="Marion DAVID" userId="ad3bef0d-db02-4846-8332-f783a325953c" providerId="ADAL" clId="{DA57DFD8-AA43-4324-827A-B828CD0FF59A}" dt="2025-05-08T06:29:05.653" v="16"/>
          <ac:spMkLst>
            <pc:docMk/>
            <pc:sldMk cId="2356615034" sldId="1741"/>
            <ac:spMk id="10" creationId="{0B5349C8-55E2-4DF5-0EC5-4D649D1F6568}"/>
          </ac:spMkLst>
        </pc:spChg>
        <pc:spChg chg="mod">
          <ac:chgData name="Marion DAVID" userId="ad3bef0d-db02-4846-8332-f783a325953c" providerId="ADAL" clId="{DA57DFD8-AA43-4324-827A-B828CD0FF59A}" dt="2025-05-08T06:29:05.653" v="16"/>
          <ac:spMkLst>
            <pc:docMk/>
            <pc:sldMk cId="2356615034" sldId="1741"/>
            <ac:spMk id="11" creationId="{26D18BDD-2365-6567-F1B5-0B954BE60A13}"/>
          </ac:spMkLst>
        </pc:spChg>
        <pc:spChg chg="mod">
          <ac:chgData name="Marion DAVID" userId="ad3bef0d-db02-4846-8332-f783a325953c" providerId="ADAL" clId="{DA57DFD8-AA43-4324-827A-B828CD0FF59A}" dt="2025-05-08T06:29:05.653" v="16"/>
          <ac:spMkLst>
            <pc:docMk/>
            <pc:sldMk cId="2356615034" sldId="1741"/>
            <ac:spMk id="12" creationId="{2FCAD74B-F91B-79D0-FFFA-CA3493A08A29}"/>
          </ac:spMkLst>
        </pc:spChg>
        <pc:spChg chg="mod">
          <ac:chgData name="Marion DAVID" userId="ad3bef0d-db02-4846-8332-f783a325953c" providerId="ADAL" clId="{DA57DFD8-AA43-4324-827A-B828CD0FF59A}" dt="2025-05-08T06:29:05.653" v="16"/>
          <ac:spMkLst>
            <pc:docMk/>
            <pc:sldMk cId="2356615034" sldId="1741"/>
            <ac:spMk id="13" creationId="{AB22C82B-3DB1-323B-AE98-EBC162712008}"/>
          </ac:spMkLst>
        </pc:spChg>
        <pc:spChg chg="mod">
          <ac:chgData name="Marion DAVID" userId="ad3bef0d-db02-4846-8332-f783a325953c" providerId="ADAL" clId="{DA57DFD8-AA43-4324-827A-B828CD0FF59A}" dt="2025-05-08T06:29:05.653" v="16"/>
          <ac:spMkLst>
            <pc:docMk/>
            <pc:sldMk cId="2356615034" sldId="1741"/>
            <ac:spMk id="14" creationId="{B0B41220-8CE1-A1C5-BC4F-421D14DDFD41}"/>
          </ac:spMkLst>
        </pc:spChg>
        <pc:spChg chg="mod">
          <ac:chgData name="Marion DAVID" userId="ad3bef0d-db02-4846-8332-f783a325953c" providerId="ADAL" clId="{DA57DFD8-AA43-4324-827A-B828CD0FF59A}" dt="2025-05-08T06:29:05.653" v="16"/>
          <ac:spMkLst>
            <pc:docMk/>
            <pc:sldMk cId="2356615034" sldId="1741"/>
            <ac:spMk id="15" creationId="{401FBE02-34B4-20DE-586E-16CCD254B21D}"/>
          </ac:spMkLst>
        </pc:spChg>
        <pc:spChg chg="mod">
          <ac:chgData name="Marion DAVID" userId="ad3bef0d-db02-4846-8332-f783a325953c" providerId="ADAL" clId="{DA57DFD8-AA43-4324-827A-B828CD0FF59A}" dt="2025-05-08T06:29:05.653" v="16"/>
          <ac:spMkLst>
            <pc:docMk/>
            <pc:sldMk cId="2356615034" sldId="1741"/>
            <ac:spMk id="17" creationId="{EC17CB93-9EA7-AC11-E506-6B7CB5B3DCA5}"/>
          </ac:spMkLst>
        </pc:spChg>
        <pc:spChg chg="mod">
          <ac:chgData name="Marion DAVID" userId="ad3bef0d-db02-4846-8332-f783a325953c" providerId="ADAL" clId="{DA57DFD8-AA43-4324-827A-B828CD0FF59A}" dt="2025-05-08T06:29:01.190" v="14" actId="164"/>
          <ac:spMkLst>
            <pc:docMk/>
            <pc:sldMk cId="2356615034" sldId="1741"/>
            <ac:spMk id="19" creationId="{0B5349C8-55E2-4DF5-0EC5-4D649D1F6568}"/>
          </ac:spMkLst>
        </pc:spChg>
        <pc:spChg chg="mod">
          <ac:chgData name="Marion DAVID" userId="ad3bef0d-db02-4846-8332-f783a325953c" providerId="ADAL" clId="{DA57DFD8-AA43-4324-827A-B828CD0FF59A}" dt="2025-05-08T06:29:05.653" v="16"/>
          <ac:spMkLst>
            <pc:docMk/>
            <pc:sldMk cId="2356615034" sldId="1741"/>
            <ac:spMk id="20" creationId="{F388D943-6A7F-5C4D-B190-A7C2B561102D}"/>
          </ac:spMkLst>
        </pc:spChg>
        <pc:spChg chg="mod">
          <ac:chgData name="Marion DAVID" userId="ad3bef0d-db02-4846-8332-f783a325953c" providerId="ADAL" clId="{DA57DFD8-AA43-4324-827A-B828CD0FF59A}" dt="2025-05-08T06:29:01.190" v="14" actId="164"/>
          <ac:spMkLst>
            <pc:docMk/>
            <pc:sldMk cId="2356615034" sldId="1741"/>
            <ac:spMk id="21" creationId="{26D18BDD-2365-6567-F1B5-0B954BE60A13}"/>
          </ac:spMkLst>
        </pc:spChg>
        <pc:spChg chg="mod">
          <ac:chgData name="Marion DAVID" userId="ad3bef0d-db02-4846-8332-f783a325953c" providerId="ADAL" clId="{DA57DFD8-AA43-4324-827A-B828CD0FF59A}" dt="2025-05-08T06:29:01.190" v="14" actId="164"/>
          <ac:spMkLst>
            <pc:docMk/>
            <pc:sldMk cId="2356615034" sldId="1741"/>
            <ac:spMk id="25" creationId="{2FCAD74B-F91B-79D0-FFFA-CA3493A08A29}"/>
          </ac:spMkLst>
        </pc:spChg>
        <pc:spChg chg="mod">
          <ac:chgData name="Marion DAVID" userId="ad3bef0d-db02-4846-8332-f783a325953c" providerId="ADAL" clId="{DA57DFD8-AA43-4324-827A-B828CD0FF59A}" dt="2025-05-08T06:29:01.190" v="14" actId="164"/>
          <ac:spMkLst>
            <pc:docMk/>
            <pc:sldMk cId="2356615034" sldId="1741"/>
            <ac:spMk id="26" creationId="{AB22C82B-3DB1-323B-AE98-EBC162712008}"/>
          </ac:spMkLst>
        </pc:spChg>
        <pc:spChg chg="mod">
          <ac:chgData name="Marion DAVID" userId="ad3bef0d-db02-4846-8332-f783a325953c" providerId="ADAL" clId="{DA57DFD8-AA43-4324-827A-B828CD0FF59A}" dt="2025-05-08T06:29:01.190" v="14" actId="164"/>
          <ac:spMkLst>
            <pc:docMk/>
            <pc:sldMk cId="2356615034" sldId="1741"/>
            <ac:spMk id="27" creationId="{B0B41220-8CE1-A1C5-BC4F-421D14DDFD41}"/>
          </ac:spMkLst>
        </pc:spChg>
        <pc:spChg chg="mod">
          <ac:chgData name="Marion DAVID" userId="ad3bef0d-db02-4846-8332-f783a325953c" providerId="ADAL" clId="{DA57DFD8-AA43-4324-827A-B828CD0FF59A}" dt="2025-05-08T06:29:05.653" v="16"/>
          <ac:spMkLst>
            <pc:docMk/>
            <pc:sldMk cId="2356615034" sldId="1741"/>
            <ac:spMk id="28" creationId="{D11F95D8-A8F8-DF39-6B25-F3C42539E975}"/>
          </ac:spMkLst>
        </pc:spChg>
        <pc:spChg chg="mod">
          <ac:chgData name="Marion DAVID" userId="ad3bef0d-db02-4846-8332-f783a325953c" providerId="ADAL" clId="{DA57DFD8-AA43-4324-827A-B828CD0FF59A}" dt="2025-05-08T06:29:01.190" v="14" actId="164"/>
          <ac:spMkLst>
            <pc:docMk/>
            <pc:sldMk cId="2356615034" sldId="1741"/>
            <ac:spMk id="32" creationId="{401FBE02-34B4-20DE-586E-16CCD254B21D}"/>
          </ac:spMkLst>
        </pc:spChg>
        <pc:spChg chg="mod">
          <ac:chgData name="Marion DAVID" userId="ad3bef0d-db02-4846-8332-f783a325953c" providerId="ADAL" clId="{DA57DFD8-AA43-4324-827A-B828CD0FF59A}" dt="2025-05-08T06:29:01.190" v="14" actId="164"/>
          <ac:spMkLst>
            <pc:docMk/>
            <pc:sldMk cId="2356615034" sldId="1741"/>
            <ac:spMk id="33" creationId="{EC17CB93-9EA7-AC11-E506-6B7CB5B3DCA5}"/>
          </ac:spMkLst>
        </pc:spChg>
        <pc:spChg chg="mod">
          <ac:chgData name="Marion DAVID" userId="ad3bef0d-db02-4846-8332-f783a325953c" providerId="ADAL" clId="{DA57DFD8-AA43-4324-827A-B828CD0FF59A}" dt="2025-05-08T06:29:01.190" v="14" actId="164"/>
          <ac:spMkLst>
            <pc:docMk/>
            <pc:sldMk cId="2356615034" sldId="1741"/>
            <ac:spMk id="34" creationId="{F388D943-6A7F-5C4D-B190-A7C2B561102D}"/>
          </ac:spMkLst>
        </pc:spChg>
        <pc:spChg chg="mod">
          <ac:chgData name="Marion DAVID" userId="ad3bef0d-db02-4846-8332-f783a325953c" providerId="ADAL" clId="{DA57DFD8-AA43-4324-827A-B828CD0FF59A}" dt="2025-05-08T06:29:01.190" v="14" actId="164"/>
          <ac:spMkLst>
            <pc:docMk/>
            <pc:sldMk cId="2356615034" sldId="1741"/>
            <ac:spMk id="49" creationId="{D11F95D8-A8F8-DF39-6B25-F3C42539E975}"/>
          </ac:spMkLst>
        </pc:spChg>
        <pc:grpChg chg="del">
          <ac:chgData name="Marion DAVID" userId="ad3bef0d-db02-4846-8332-f783a325953c" providerId="ADAL" clId="{DA57DFD8-AA43-4324-827A-B828CD0FF59A}" dt="2025-05-08T06:29:04.080" v="15" actId="21"/>
          <ac:grpSpMkLst>
            <pc:docMk/>
            <pc:sldMk cId="2356615034" sldId="1741"/>
            <ac:grpSpMk id="2" creationId="{D7CC7C31-4339-FBB8-CE23-3904DA30FB09}"/>
          </ac:grpSpMkLst>
        </pc:grpChg>
        <pc:picChg chg="mod">
          <ac:chgData name="Marion DAVID" userId="ad3bef0d-db02-4846-8332-f783a325953c" providerId="ADAL" clId="{DA57DFD8-AA43-4324-827A-B828CD0FF59A}" dt="2025-05-08T06:29:05.653" v="16"/>
          <ac:picMkLst>
            <pc:docMk/>
            <pc:sldMk cId="2356615034" sldId="1741"/>
            <ac:picMk id="6" creationId="{B7273AF0-5336-EEAD-1E2A-D438011DF594}"/>
          </ac:picMkLst>
        </pc:picChg>
        <pc:picChg chg="add mod">
          <ac:chgData name="Marion DAVID" userId="ad3bef0d-db02-4846-8332-f783a325953c" providerId="ADAL" clId="{DA57DFD8-AA43-4324-827A-B828CD0FF59A}" dt="2025-05-08T06:29:14.038" v="53" actId="1035"/>
          <ac:picMkLst>
            <pc:docMk/>
            <pc:sldMk cId="2356615034" sldId="1741"/>
            <ac:picMk id="30" creationId="{75C561A8-4014-3ADE-36E2-318D6CA40FBC}"/>
          </ac:picMkLst>
        </pc:picChg>
        <pc:picChg chg="mod">
          <ac:chgData name="Marion DAVID" userId="ad3bef0d-db02-4846-8332-f783a325953c" providerId="ADAL" clId="{DA57DFD8-AA43-4324-827A-B828CD0FF59A}" dt="2025-05-08T06:29:01.190" v="14" actId="164"/>
          <ac:picMkLst>
            <pc:docMk/>
            <pc:sldMk cId="2356615034" sldId="1741"/>
            <ac:picMk id="44" creationId="{FD712625-E3EF-EA70-0704-F0449ECC1EDA}"/>
          </ac:picMkLst>
        </pc:picChg>
      </pc:sldChg>
      <pc:sldChg chg="del">
        <pc:chgData name="Marion DAVID" userId="ad3bef0d-db02-4846-8332-f783a325953c" providerId="ADAL" clId="{DA57DFD8-AA43-4324-827A-B828CD0FF59A}" dt="2025-05-08T06:26:19.006" v="7" actId="47"/>
        <pc:sldMkLst>
          <pc:docMk/>
          <pc:sldMk cId="51955424" sldId="1742"/>
        </pc:sldMkLst>
      </pc:sldChg>
      <pc:sldChg chg="del">
        <pc:chgData name="Marion DAVID" userId="ad3bef0d-db02-4846-8332-f783a325953c" providerId="ADAL" clId="{DA57DFD8-AA43-4324-827A-B828CD0FF59A}" dt="2025-05-08T06:26:11.814" v="1" actId="47"/>
        <pc:sldMkLst>
          <pc:docMk/>
          <pc:sldMk cId="4013248784" sldId="1744"/>
        </pc:sldMkLst>
      </pc:sldChg>
      <pc:sldChg chg="addSp delSp modSp mod">
        <pc:chgData name="Marion DAVID" userId="ad3bef0d-db02-4846-8332-f783a325953c" providerId="ADAL" clId="{DA57DFD8-AA43-4324-827A-B828CD0FF59A}" dt="2025-05-08T06:30:46.739" v="77" actId="1035"/>
        <pc:sldMkLst>
          <pc:docMk/>
          <pc:sldMk cId="3093578792" sldId="1745"/>
        </pc:sldMkLst>
        <pc:grpChg chg="del">
          <ac:chgData name="Marion DAVID" userId="ad3bef0d-db02-4846-8332-f783a325953c" providerId="ADAL" clId="{DA57DFD8-AA43-4324-827A-B828CD0FF59A}" dt="2025-05-08T06:30:38.612" v="58" actId="21"/>
          <ac:grpSpMkLst>
            <pc:docMk/>
            <pc:sldMk cId="3093578792" sldId="1745"/>
            <ac:grpSpMk id="6" creationId="{3C820E6F-AD70-5968-960C-031A02B8892D}"/>
          </ac:grpSpMkLst>
        </pc:grpChg>
        <pc:picChg chg="mod">
          <ac:chgData name="Marion DAVID" userId="ad3bef0d-db02-4846-8332-f783a325953c" providerId="ADAL" clId="{DA57DFD8-AA43-4324-827A-B828CD0FF59A}" dt="2025-05-08T06:30:39.886" v="59"/>
          <ac:picMkLst>
            <pc:docMk/>
            <pc:sldMk cId="3093578792" sldId="1745"/>
            <ac:picMk id="3" creationId="{AF911F3E-20FB-56B3-2A39-5CE80FFDB82E}"/>
          </ac:picMkLst>
        </pc:picChg>
        <pc:picChg chg="mod">
          <ac:chgData name="Marion DAVID" userId="ad3bef0d-db02-4846-8332-f783a325953c" providerId="ADAL" clId="{DA57DFD8-AA43-4324-827A-B828CD0FF59A}" dt="2025-05-08T06:30:39.886" v="59"/>
          <ac:picMkLst>
            <pc:docMk/>
            <pc:sldMk cId="3093578792" sldId="1745"/>
            <ac:picMk id="4" creationId="{611BF237-1CD8-7A58-5E42-C39C669A9C29}"/>
          </ac:picMkLst>
        </pc:picChg>
        <pc:picChg chg="mod">
          <ac:chgData name="Marion DAVID" userId="ad3bef0d-db02-4846-8332-f783a325953c" providerId="ADAL" clId="{DA57DFD8-AA43-4324-827A-B828CD0FF59A}" dt="2025-05-08T06:30:39.886" v="59"/>
          <ac:picMkLst>
            <pc:docMk/>
            <pc:sldMk cId="3093578792" sldId="1745"/>
            <ac:picMk id="7" creationId="{16E0FE39-9705-6323-289B-B0468107D9E2}"/>
          </ac:picMkLst>
        </pc:picChg>
        <pc:picChg chg="mod">
          <ac:chgData name="Marion DAVID" userId="ad3bef0d-db02-4846-8332-f783a325953c" providerId="ADAL" clId="{DA57DFD8-AA43-4324-827A-B828CD0FF59A}" dt="2025-05-08T06:30:39.886" v="59"/>
          <ac:picMkLst>
            <pc:docMk/>
            <pc:sldMk cId="3093578792" sldId="1745"/>
            <ac:picMk id="8" creationId="{CBBCB995-D859-056E-9AA8-FEF73E9FFCB7}"/>
          </ac:picMkLst>
        </pc:picChg>
        <pc:picChg chg="mod">
          <ac:chgData name="Marion DAVID" userId="ad3bef0d-db02-4846-8332-f783a325953c" providerId="ADAL" clId="{DA57DFD8-AA43-4324-827A-B828CD0FF59A}" dt="2025-05-08T06:30:39.886" v="59"/>
          <ac:picMkLst>
            <pc:docMk/>
            <pc:sldMk cId="3093578792" sldId="1745"/>
            <ac:picMk id="9" creationId="{D6633BD9-60C1-878F-C504-FC1F17A8D4B9}"/>
          </ac:picMkLst>
        </pc:picChg>
        <pc:picChg chg="mod">
          <ac:chgData name="Marion DAVID" userId="ad3bef0d-db02-4846-8332-f783a325953c" providerId="ADAL" clId="{DA57DFD8-AA43-4324-827A-B828CD0FF59A}" dt="2025-05-08T06:30:39.886" v="59"/>
          <ac:picMkLst>
            <pc:docMk/>
            <pc:sldMk cId="3093578792" sldId="1745"/>
            <ac:picMk id="12" creationId="{54AEF78E-7E6B-2E2F-D7B5-85BCC1C055DF}"/>
          </ac:picMkLst>
        </pc:picChg>
        <pc:picChg chg="mod">
          <ac:chgData name="Marion DAVID" userId="ad3bef0d-db02-4846-8332-f783a325953c" providerId="ADAL" clId="{DA57DFD8-AA43-4324-827A-B828CD0FF59A}" dt="2025-05-08T06:30:39.886" v="59"/>
          <ac:picMkLst>
            <pc:docMk/>
            <pc:sldMk cId="3093578792" sldId="1745"/>
            <ac:picMk id="14" creationId="{8AD8CE98-A22B-B560-7D85-A99BA7FB1D88}"/>
          </ac:picMkLst>
        </pc:picChg>
        <pc:picChg chg="mod">
          <ac:chgData name="Marion DAVID" userId="ad3bef0d-db02-4846-8332-f783a325953c" providerId="ADAL" clId="{DA57DFD8-AA43-4324-827A-B828CD0FF59A}" dt="2025-05-08T06:30:39.886" v="59"/>
          <ac:picMkLst>
            <pc:docMk/>
            <pc:sldMk cId="3093578792" sldId="1745"/>
            <ac:picMk id="16" creationId="{BD4D89B8-B0A4-AEDE-1262-30D1B8B57161}"/>
          </ac:picMkLst>
        </pc:picChg>
        <pc:picChg chg="mod">
          <ac:chgData name="Marion DAVID" userId="ad3bef0d-db02-4846-8332-f783a325953c" providerId="ADAL" clId="{DA57DFD8-AA43-4324-827A-B828CD0FF59A}" dt="2025-05-08T06:30:39.886" v="59"/>
          <ac:picMkLst>
            <pc:docMk/>
            <pc:sldMk cId="3093578792" sldId="1745"/>
            <ac:picMk id="29" creationId="{70F220FD-A729-95D4-9DF4-252914996897}"/>
          </ac:picMkLst>
        </pc:picChg>
        <pc:picChg chg="mod">
          <ac:chgData name="Marion DAVID" userId="ad3bef0d-db02-4846-8332-f783a325953c" providerId="ADAL" clId="{DA57DFD8-AA43-4324-827A-B828CD0FF59A}" dt="2025-05-08T06:30:39.886" v="59"/>
          <ac:picMkLst>
            <pc:docMk/>
            <pc:sldMk cId="3093578792" sldId="1745"/>
            <ac:picMk id="30" creationId="{D9ACDEEF-83B3-816D-995A-557BD1AAB33F}"/>
          </ac:picMkLst>
        </pc:picChg>
        <pc:picChg chg="add mod">
          <ac:chgData name="Marion DAVID" userId="ad3bef0d-db02-4846-8332-f783a325953c" providerId="ADAL" clId="{DA57DFD8-AA43-4324-827A-B828CD0FF59A}" dt="2025-05-08T06:30:46.739" v="77" actId="1035"/>
          <ac:picMkLst>
            <pc:docMk/>
            <pc:sldMk cId="3093578792" sldId="1745"/>
            <ac:picMk id="31" creationId="{5A454F56-3245-57A8-D214-2C592FB2A42B}"/>
          </ac:picMkLst>
        </pc:picChg>
      </pc:sldChg>
      <pc:sldChg chg="addSp delSp modSp mod">
        <pc:chgData name="Marion DAVID" userId="ad3bef0d-db02-4846-8332-f783a325953c" providerId="ADAL" clId="{DA57DFD8-AA43-4324-827A-B828CD0FF59A}" dt="2025-05-08T06:30:23.082" v="57" actId="1076"/>
        <pc:sldMkLst>
          <pc:docMk/>
          <pc:sldMk cId="342233322" sldId="1746"/>
        </pc:sldMkLst>
        <pc:grpChg chg="del">
          <ac:chgData name="Marion DAVID" userId="ad3bef0d-db02-4846-8332-f783a325953c" providerId="ADAL" clId="{DA57DFD8-AA43-4324-827A-B828CD0FF59A}" dt="2025-05-08T06:30:09.154" v="55" actId="21"/>
          <ac:grpSpMkLst>
            <pc:docMk/>
            <pc:sldMk cId="342233322" sldId="1746"/>
            <ac:grpSpMk id="16" creationId="{C8ACA934-C7E4-A993-F4CB-ADB71D33ABF4}"/>
          </ac:grpSpMkLst>
        </pc:grpChg>
        <pc:picChg chg="mod">
          <ac:chgData name="Marion DAVID" userId="ad3bef0d-db02-4846-8332-f783a325953c" providerId="ADAL" clId="{DA57DFD8-AA43-4324-827A-B828CD0FF59A}" dt="2025-05-08T06:30:00.457" v="54" actId="164"/>
          <ac:picMkLst>
            <pc:docMk/>
            <pc:sldMk cId="342233322" sldId="1746"/>
            <ac:picMk id="3" creationId="{00000000-0000-0000-0000-000000000000}"/>
          </ac:picMkLst>
        </pc:picChg>
        <pc:picChg chg="mod">
          <ac:chgData name="Marion DAVID" userId="ad3bef0d-db02-4846-8332-f783a325953c" providerId="ADAL" clId="{DA57DFD8-AA43-4324-827A-B828CD0FF59A}" dt="2025-05-08T06:30:00.457" v="54" actId="164"/>
          <ac:picMkLst>
            <pc:docMk/>
            <pc:sldMk cId="342233322" sldId="1746"/>
            <ac:picMk id="4" creationId="{00000000-0000-0000-0000-000000000000}"/>
          </ac:picMkLst>
        </pc:picChg>
        <pc:picChg chg="mod">
          <ac:chgData name="Marion DAVID" userId="ad3bef0d-db02-4846-8332-f783a325953c" providerId="ADAL" clId="{DA57DFD8-AA43-4324-827A-B828CD0FF59A}" dt="2025-05-08T06:30:00.457" v="54" actId="164"/>
          <ac:picMkLst>
            <pc:docMk/>
            <pc:sldMk cId="342233322" sldId="1746"/>
            <ac:picMk id="5" creationId="{00000000-0000-0000-0000-000000000000}"/>
          </ac:picMkLst>
        </pc:picChg>
        <pc:picChg chg="mod">
          <ac:chgData name="Marion DAVID" userId="ad3bef0d-db02-4846-8332-f783a325953c" providerId="ADAL" clId="{DA57DFD8-AA43-4324-827A-B828CD0FF59A}" dt="2025-05-08T06:30:00.457" v="54" actId="164"/>
          <ac:picMkLst>
            <pc:docMk/>
            <pc:sldMk cId="342233322" sldId="1746"/>
            <ac:picMk id="6" creationId="{00000000-0000-0000-0000-000000000000}"/>
          </ac:picMkLst>
        </pc:picChg>
        <pc:picChg chg="mod">
          <ac:chgData name="Marion DAVID" userId="ad3bef0d-db02-4846-8332-f783a325953c" providerId="ADAL" clId="{DA57DFD8-AA43-4324-827A-B828CD0FF59A}" dt="2025-05-08T06:30:00.457" v="54" actId="164"/>
          <ac:picMkLst>
            <pc:docMk/>
            <pc:sldMk cId="342233322" sldId="1746"/>
            <ac:picMk id="8" creationId="{00000000-0000-0000-0000-000000000000}"/>
          </ac:picMkLst>
        </pc:picChg>
        <pc:picChg chg="mod">
          <ac:chgData name="Marion DAVID" userId="ad3bef0d-db02-4846-8332-f783a325953c" providerId="ADAL" clId="{DA57DFD8-AA43-4324-827A-B828CD0FF59A}" dt="2025-05-08T06:30:00.457" v="54" actId="164"/>
          <ac:picMkLst>
            <pc:docMk/>
            <pc:sldMk cId="342233322" sldId="1746"/>
            <ac:picMk id="10" creationId="{00000000-0000-0000-0000-000000000000}"/>
          </ac:picMkLst>
        </pc:picChg>
        <pc:picChg chg="mod">
          <ac:chgData name="Marion DAVID" userId="ad3bef0d-db02-4846-8332-f783a325953c" providerId="ADAL" clId="{DA57DFD8-AA43-4324-827A-B828CD0FF59A}" dt="2025-05-08T06:30:00.457" v="54" actId="164"/>
          <ac:picMkLst>
            <pc:docMk/>
            <pc:sldMk cId="342233322" sldId="1746"/>
            <ac:picMk id="11" creationId="{00000000-0000-0000-0000-000000000000}"/>
          </ac:picMkLst>
        </pc:picChg>
        <pc:picChg chg="mod">
          <ac:chgData name="Marion DAVID" userId="ad3bef0d-db02-4846-8332-f783a325953c" providerId="ADAL" clId="{DA57DFD8-AA43-4324-827A-B828CD0FF59A}" dt="2025-05-08T06:30:00.457" v="54" actId="164"/>
          <ac:picMkLst>
            <pc:docMk/>
            <pc:sldMk cId="342233322" sldId="1746"/>
            <ac:picMk id="12" creationId="{00000000-0000-0000-0000-000000000000}"/>
          </ac:picMkLst>
        </pc:picChg>
        <pc:picChg chg="mod">
          <ac:chgData name="Marion DAVID" userId="ad3bef0d-db02-4846-8332-f783a325953c" providerId="ADAL" clId="{DA57DFD8-AA43-4324-827A-B828CD0FF59A}" dt="2025-05-08T06:30:00.457" v="54" actId="164"/>
          <ac:picMkLst>
            <pc:docMk/>
            <pc:sldMk cId="342233322" sldId="1746"/>
            <ac:picMk id="13" creationId="{00000000-0000-0000-0000-000000000000}"/>
          </ac:picMkLst>
        </pc:picChg>
        <pc:picChg chg="mod">
          <ac:chgData name="Marion DAVID" userId="ad3bef0d-db02-4846-8332-f783a325953c" providerId="ADAL" clId="{DA57DFD8-AA43-4324-827A-B828CD0FF59A}" dt="2025-05-08T06:30:00.457" v="54" actId="164"/>
          <ac:picMkLst>
            <pc:docMk/>
            <pc:sldMk cId="342233322" sldId="1746"/>
            <ac:picMk id="14" creationId="{00000000-0000-0000-0000-000000000000}"/>
          </ac:picMkLst>
        </pc:picChg>
        <pc:picChg chg="add mod">
          <ac:chgData name="Marion DAVID" userId="ad3bef0d-db02-4846-8332-f783a325953c" providerId="ADAL" clId="{DA57DFD8-AA43-4324-827A-B828CD0FF59A}" dt="2025-05-08T06:30:23.082" v="57" actId="1076"/>
          <ac:picMkLst>
            <pc:docMk/>
            <pc:sldMk cId="342233322" sldId="1746"/>
            <ac:picMk id="17" creationId="{3DDBE091-645E-2858-0F6F-61276AB5F4EB}"/>
          </ac:picMkLst>
        </pc:picChg>
      </pc:sldChg>
      <pc:sldChg chg="del">
        <pc:chgData name="Marion DAVID" userId="ad3bef0d-db02-4846-8332-f783a325953c" providerId="ADAL" clId="{DA57DFD8-AA43-4324-827A-B828CD0FF59A}" dt="2025-05-08T06:26:13.688" v="3" actId="47"/>
        <pc:sldMkLst>
          <pc:docMk/>
          <pc:sldMk cId="3215292220" sldId="1749"/>
        </pc:sldMkLst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8056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8056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r">
              <a:defRPr sz="1200"/>
            </a:lvl1pPr>
          </a:lstStyle>
          <a:p>
            <a:fld id="{EEF2F985-F40F-49F3-AA56-FFA27984241A}" type="datetimeFigureOut">
              <a:rPr lang="fr-FR" smtClean="0"/>
              <a:pPr/>
              <a:t>23/05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1" tIns="45715" rIns="91431" bIns="45715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31" tIns="45715" rIns="91431" bIns="45715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1" y="9428585"/>
            <a:ext cx="2945659" cy="498054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4" y="9428585"/>
            <a:ext cx="2945659" cy="498054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r">
              <a:defRPr sz="1200"/>
            </a:lvl1pPr>
          </a:lstStyle>
          <a:p>
            <a:fld id="{E9E5ED04-12F3-4FEC-82EB-C68991CAD5FF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59413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FR"/>
              <a:t>Origine photos:</a:t>
            </a:r>
          </a:p>
          <a:p>
            <a:r>
              <a:rPr lang="fr-FR"/>
              <a:t>Aude</a:t>
            </a:r>
            <a:r>
              <a:rPr lang="fr-FR" baseline="0"/>
              <a:t> = manip ?</a:t>
            </a:r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E5ED04-12F3-4FEC-82EB-C68991CAD5FF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00623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F3633-76C2-478E-93D9-57AC4AB0309B}" type="datetimeFigureOut">
              <a:rPr lang="fr-FR" smtClean="0"/>
              <a:pPr/>
              <a:t>23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29CBE-6203-4A5B-9B9A-27B34CCF1F8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2292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F3633-76C2-478E-93D9-57AC4AB0309B}" type="datetimeFigureOut">
              <a:rPr lang="fr-FR" smtClean="0"/>
              <a:pPr/>
              <a:t>23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29CBE-6203-4A5B-9B9A-27B34CCF1F8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1887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F3633-76C2-478E-93D9-57AC4AB0309B}" type="datetimeFigureOut">
              <a:rPr lang="fr-FR" smtClean="0"/>
              <a:pPr/>
              <a:t>23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29CBE-6203-4A5B-9B9A-27B34CCF1F8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784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F3633-76C2-478E-93D9-57AC4AB0309B}" type="datetimeFigureOut">
              <a:rPr lang="fr-FR" smtClean="0"/>
              <a:pPr/>
              <a:t>23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29CBE-6203-4A5B-9B9A-27B34CCF1F8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3493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F3633-76C2-478E-93D9-57AC4AB0309B}" type="datetimeFigureOut">
              <a:rPr lang="fr-FR" smtClean="0"/>
              <a:pPr/>
              <a:t>23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29CBE-6203-4A5B-9B9A-27B34CCF1F8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3174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F3633-76C2-478E-93D9-57AC4AB0309B}" type="datetimeFigureOut">
              <a:rPr lang="fr-FR" smtClean="0"/>
              <a:pPr/>
              <a:t>23/05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29CBE-6203-4A5B-9B9A-27B34CCF1F8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6599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F3633-76C2-478E-93D9-57AC4AB0309B}" type="datetimeFigureOut">
              <a:rPr lang="fr-FR" smtClean="0"/>
              <a:pPr/>
              <a:t>23/05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29CBE-6203-4A5B-9B9A-27B34CCF1F8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86586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F3633-76C2-478E-93D9-57AC4AB0309B}" type="datetimeFigureOut">
              <a:rPr lang="fr-FR" smtClean="0"/>
              <a:pPr/>
              <a:t>23/05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29CBE-6203-4A5B-9B9A-27B34CCF1F8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17947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F3633-76C2-478E-93D9-57AC4AB0309B}" type="datetimeFigureOut">
              <a:rPr lang="fr-FR" smtClean="0"/>
              <a:pPr/>
              <a:t>23/05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29CBE-6203-4A5B-9B9A-27B34CCF1F8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0476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F3633-76C2-478E-93D9-57AC4AB0309B}" type="datetimeFigureOut">
              <a:rPr lang="fr-FR" smtClean="0"/>
              <a:pPr/>
              <a:t>23/05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29CBE-6203-4A5B-9B9A-27B34CCF1F8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0759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F3633-76C2-478E-93D9-57AC4AB0309B}" type="datetimeFigureOut">
              <a:rPr lang="fr-FR" smtClean="0"/>
              <a:pPr/>
              <a:t>23/05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29CBE-6203-4A5B-9B9A-27B34CCF1F8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58243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8F3633-76C2-478E-93D9-57AC4AB0309B}" type="datetimeFigureOut">
              <a:rPr lang="fr-FR" smtClean="0"/>
              <a:pPr/>
              <a:t>23/05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729CBE-6203-4A5B-9B9A-27B34CCF1F87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4697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sv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3.png"/><Relationship Id="rId4" Type="http://schemas.openxmlformats.org/officeDocument/2006/relationships/image" Target="../media/image12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Rectangle 171">
            <a:extLst>
              <a:ext uri="{FF2B5EF4-FFF2-40B4-BE49-F238E27FC236}">
                <a16:creationId xmlns:a16="http://schemas.microsoft.com/office/drawing/2014/main" id="{F758CDBD-2A5C-47FB-A289-C6A15CC4CE45}"/>
              </a:ext>
            </a:extLst>
          </p:cNvPr>
          <p:cNvSpPr/>
          <p:nvPr/>
        </p:nvSpPr>
        <p:spPr>
          <a:xfrm>
            <a:off x="407338" y="4547983"/>
            <a:ext cx="6099402" cy="754053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pPr algn="just" fontAlgn="base"/>
            <a:r>
              <a:rPr lang="en-US" sz="1100" b="1" dirty="0">
                <a:ea typeface="Calibri" panose="020F0502020204030204" pitchFamily="34" charset="0"/>
                <a:cs typeface="Times New Roman"/>
              </a:rPr>
              <a:t>Supplemental Figure S1.</a:t>
            </a:r>
            <a:endParaRPr lang="en-US" sz="1100" dirty="0">
              <a:ea typeface="Calibri" panose="020F0502020204030204" pitchFamily="34" charset="0"/>
              <a:cs typeface="Times New Roman"/>
            </a:endParaRPr>
          </a:p>
          <a:p>
            <a:pPr algn="just"/>
            <a:r>
              <a:rPr lang="en-US" sz="1100" b="1" dirty="0">
                <a:ea typeface="Calibri" panose="020F0502020204030204" pitchFamily="34" charset="0"/>
                <a:cs typeface="Times New Roman"/>
              </a:rPr>
              <a:t>Validation of CHO cell lines expressing the </a:t>
            </a:r>
            <a:r>
              <a:rPr lang="en-US" sz="1100" b="1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mouse, human and rhesus monkey TfR1 receptor</a:t>
            </a:r>
            <a:endParaRPr lang="fr-FR" sz="1100" dirty="0">
              <a:effectLst/>
              <a:ea typeface="Times New Roman" panose="02020603050405020304" pitchFamily="18" charset="0"/>
            </a:endParaRPr>
          </a:p>
          <a:p>
            <a:pPr algn="just"/>
            <a:endParaRPr lang="en-US" sz="1000" dirty="0">
              <a:effectLst/>
              <a:latin typeface="Calibri"/>
              <a:ea typeface="Times New Roman" panose="02020603050405020304" pitchFamily="18" charset="0"/>
              <a:cs typeface="Times New Roman"/>
            </a:endParaRPr>
          </a:p>
          <a:p>
            <a:pPr algn="just"/>
            <a:endParaRPr lang="en-US" sz="11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18" name="Image 117">
            <a:extLst>
              <a:ext uri="{FF2B5EF4-FFF2-40B4-BE49-F238E27FC236}">
                <a16:creationId xmlns:a16="http://schemas.microsoft.com/office/drawing/2014/main" id="{C3038C88-283B-6D87-1821-0EFBD5C4D3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4681" y="517989"/>
            <a:ext cx="6608637" cy="39322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38668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e 5">
            <a:extLst>
              <a:ext uri="{FF2B5EF4-FFF2-40B4-BE49-F238E27FC236}">
                <a16:creationId xmlns:a16="http://schemas.microsoft.com/office/drawing/2014/main" id="{78DB3181-B25B-613A-DEF0-6624BE0D589E}"/>
              </a:ext>
            </a:extLst>
          </p:cNvPr>
          <p:cNvGrpSpPr/>
          <p:nvPr/>
        </p:nvGrpSpPr>
        <p:grpSpPr>
          <a:xfrm>
            <a:off x="1533411" y="3590435"/>
            <a:ext cx="878163" cy="536535"/>
            <a:chOff x="1563382" y="4159688"/>
            <a:chExt cx="1026812" cy="627355"/>
          </a:xfrm>
        </p:grpSpPr>
        <p:grpSp>
          <p:nvGrpSpPr>
            <p:cNvPr id="21" name="Groupe 20">
              <a:extLst>
                <a:ext uri="{FF2B5EF4-FFF2-40B4-BE49-F238E27FC236}">
                  <a16:creationId xmlns:a16="http://schemas.microsoft.com/office/drawing/2014/main" id="{C98C11CC-F107-5239-C946-CC870284E082}"/>
                </a:ext>
              </a:extLst>
            </p:cNvPr>
            <p:cNvGrpSpPr/>
            <p:nvPr/>
          </p:nvGrpSpPr>
          <p:grpSpPr>
            <a:xfrm>
              <a:off x="1946770" y="4159688"/>
              <a:ext cx="643424" cy="627355"/>
              <a:chOff x="1771160" y="3616384"/>
              <a:chExt cx="643424" cy="627355"/>
            </a:xfrm>
          </p:grpSpPr>
          <p:cxnSp>
            <p:nvCxnSpPr>
              <p:cNvPr id="13" name="Connecteur droit 12">
                <a:extLst>
                  <a:ext uri="{FF2B5EF4-FFF2-40B4-BE49-F238E27FC236}">
                    <a16:creationId xmlns:a16="http://schemas.microsoft.com/office/drawing/2014/main" id="{84BAFF9F-6EA4-F082-95D9-2F26B883D5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71160" y="3930061"/>
                <a:ext cx="513294" cy="0"/>
              </a:xfrm>
              <a:prstGeom prst="line">
                <a:avLst/>
              </a:prstGeom>
              <a:ln w="38100">
                <a:prstDash val="sysDash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17" name="Graphique 16" descr="Ligne fléchée : incurvée dans le sens des aiguilles d’une montre avec un remplissage uni">
                <a:extLst>
                  <a:ext uri="{FF2B5EF4-FFF2-40B4-BE49-F238E27FC236}">
                    <a16:creationId xmlns:a16="http://schemas.microsoft.com/office/drawing/2014/main" id="{47A1F5F3-9C44-4FFC-B37C-2B8A71269D2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96DAC541-7B7A-43D3-8B79-37D633B846F1}">
                    <asvg:svgBlip xmlns:asvg="http://schemas.microsoft.com/office/drawing/2016/SVG/main" r:embed="rId3"/>
                  </a:ext>
                </a:extLst>
              </a:blip>
              <a:stretch>
                <a:fillRect/>
              </a:stretch>
            </p:blipFill>
            <p:spPr>
              <a:xfrm rot="11150658">
                <a:off x="1787229" y="3616384"/>
                <a:ext cx="627355" cy="627355"/>
              </a:xfrm>
              <a:prstGeom prst="rect">
                <a:avLst/>
              </a:prstGeom>
            </p:spPr>
          </p:pic>
        </p:grp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4D4A3AEE-1426-15ED-91F1-AFB0669C413D}"/>
                </a:ext>
              </a:extLst>
            </p:cNvPr>
            <p:cNvSpPr txBox="1"/>
            <p:nvPr/>
          </p:nvSpPr>
          <p:spPr>
            <a:xfrm>
              <a:off x="1563382" y="4325591"/>
              <a:ext cx="438973" cy="2772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41" b="1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90 °</a:t>
              </a:r>
            </a:p>
          </p:txBody>
        </p:sp>
      </p:grpSp>
      <p:sp>
        <p:nvSpPr>
          <p:cNvPr id="25" name="ZoneTexte 24">
            <a:extLst>
              <a:ext uri="{FF2B5EF4-FFF2-40B4-BE49-F238E27FC236}">
                <a16:creationId xmlns:a16="http://schemas.microsoft.com/office/drawing/2014/main" id="{C11788FD-FA0D-9ADB-5A6C-6FF15210748B}"/>
              </a:ext>
            </a:extLst>
          </p:cNvPr>
          <p:cNvSpPr txBox="1"/>
          <p:nvPr/>
        </p:nvSpPr>
        <p:spPr>
          <a:xfrm>
            <a:off x="3480896" y="6897580"/>
            <a:ext cx="3260829" cy="2371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41" b="1" u="sng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fR1 </a:t>
            </a:r>
            <a:r>
              <a:rPr lang="fr-FR" sz="941" b="1" u="sng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argeted</a:t>
            </a:r>
            <a:r>
              <a:rPr lang="fr-FR" sz="941" b="1" u="sng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41" b="1" u="sng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gion</a:t>
            </a:r>
            <a:r>
              <a:rPr lang="fr-FR" sz="941" b="1" u="sng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or </a:t>
            </a:r>
            <a:r>
              <a:rPr lang="fr-FR" sz="941" b="1" u="sng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edicted</a:t>
            </a:r>
            <a:r>
              <a:rPr lang="fr-FR" sz="941" b="1" u="sng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41" b="1" u="sng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argeted</a:t>
            </a:r>
            <a:r>
              <a:rPr lang="fr-FR" sz="941" b="1" u="sng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41" b="1" u="sng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gion</a:t>
            </a:r>
            <a:r>
              <a:rPr lang="fr-FR" sz="941" b="1" u="sng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41" b="1" u="sng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mparison</a:t>
            </a:r>
            <a:endParaRPr lang="fr-FR" sz="941" b="1" u="sng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4BF42FD0-C25E-88BE-46DC-883DE1356FE0}"/>
              </a:ext>
            </a:extLst>
          </p:cNvPr>
          <p:cNvSpPr txBox="1"/>
          <p:nvPr/>
        </p:nvSpPr>
        <p:spPr>
          <a:xfrm>
            <a:off x="4376959" y="3378593"/>
            <a:ext cx="1646605" cy="2371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41" b="1" u="sng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fR1 </a:t>
            </a:r>
            <a:r>
              <a:rPr lang="fr-FR" sz="941" b="1" u="sng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ctodomain</a:t>
            </a:r>
            <a:r>
              <a:rPr lang="fr-FR" sz="941" b="1" u="sng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41" b="1" u="sng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mparison</a:t>
            </a:r>
            <a:endParaRPr lang="fr-FR" sz="941" b="1" u="sng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7" name="Image 36" descr="Une image contenant art, chaos&#10;&#10;Description générée automatiquement">
            <a:extLst>
              <a:ext uri="{FF2B5EF4-FFF2-40B4-BE49-F238E27FC236}">
                <a16:creationId xmlns:a16="http://schemas.microsoft.com/office/drawing/2014/main" id="{1AE11706-6EB3-A4EF-470A-0EDB279D999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81" t="15630" r="33724" b="4418"/>
          <a:stretch/>
        </p:blipFill>
        <p:spPr>
          <a:xfrm>
            <a:off x="583559" y="404999"/>
            <a:ext cx="3117993" cy="2808638"/>
          </a:xfrm>
          <a:prstGeom prst="rect">
            <a:avLst/>
          </a:prstGeom>
        </p:spPr>
      </p:pic>
      <p:pic>
        <p:nvPicPr>
          <p:cNvPr id="39" name="Image 38" descr="Une image contenant art, dessin humoristique, capture d’écran, jouet&#10;&#10;Description générée automatiquement">
            <a:extLst>
              <a:ext uri="{FF2B5EF4-FFF2-40B4-BE49-F238E27FC236}">
                <a16:creationId xmlns:a16="http://schemas.microsoft.com/office/drawing/2014/main" id="{F91EA0BD-2D18-76B1-DD02-9CF8774B94B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32"/>
          <a:stretch/>
        </p:blipFill>
        <p:spPr>
          <a:xfrm>
            <a:off x="582685" y="4503766"/>
            <a:ext cx="3118867" cy="2092696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99A8595A-6D9F-F64E-97A3-6625FA6494D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20260" y="225062"/>
            <a:ext cx="2160000" cy="9228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73BF6D55-4A35-1E26-AB60-993A746F218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20260" y="1276239"/>
            <a:ext cx="2160000" cy="9228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Image 25">
            <a:extLst>
              <a:ext uri="{FF2B5EF4-FFF2-40B4-BE49-F238E27FC236}">
                <a16:creationId xmlns:a16="http://schemas.microsoft.com/office/drawing/2014/main" id="{1544CEBB-2D44-3214-0FB6-C5E4F84082F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20260" y="2327416"/>
            <a:ext cx="2160000" cy="9228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Image 27">
            <a:extLst>
              <a:ext uri="{FF2B5EF4-FFF2-40B4-BE49-F238E27FC236}">
                <a16:creationId xmlns:a16="http://schemas.microsoft.com/office/drawing/2014/main" id="{2BBD6808-4795-70B8-F0A0-89D6D7E08BA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15315" y="3744050"/>
            <a:ext cx="2160000" cy="9228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Image 30">
            <a:extLst>
              <a:ext uri="{FF2B5EF4-FFF2-40B4-BE49-F238E27FC236}">
                <a16:creationId xmlns:a16="http://schemas.microsoft.com/office/drawing/2014/main" id="{4E30AD40-D8B1-3068-2322-2DD720FB298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115315" y="4795227"/>
            <a:ext cx="2160000" cy="9228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Image 33">
            <a:extLst>
              <a:ext uri="{FF2B5EF4-FFF2-40B4-BE49-F238E27FC236}">
                <a16:creationId xmlns:a16="http://schemas.microsoft.com/office/drawing/2014/main" id="{D32EF2BB-2ACC-5566-DD49-8AD1C1926CB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115315" y="5846404"/>
            <a:ext cx="2160000" cy="92283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ZoneTexte 35">
            <a:extLst>
              <a:ext uri="{FF2B5EF4-FFF2-40B4-BE49-F238E27FC236}">
                <a16:creationId xmlns:a16="http://schemas.microsoft.com/office/drawing/2014/main" id="{6CE66BAA-2197-3C00-7D1E-B0061DC035E8}"/>
              </a:ext>
            </a:extLst>
          </p:cNvPr>
          <p:cNvSpPr txBox="1"/>
          <p:nvPr/>
        </p:nvSpPr>
        <p:spPr>
          <a:xfrm>
            <a:off x="195408" y="7198360"/>
            <a:ext cx="6466651" cy="586797"/>
          </a:xfrm>
          <a:prstGeom prst="rect">
            <a:avLst/>
          </a:prstGeom>
          <a:noFill/>
        </p:spPr>
        <p:txBody>
          <a:bodyPr wrap="square" lIns="78203" tIns="39101" rIns="78203" bIns="39101" anchor="t">
            <a:spAutoFit/>
          </a:bodyPr>
          <a:lstStyle>
            <a:defPPr>
              <a:defRPr lang="en-US"/>
            </a:defPPr>
            <a:lvl1pPr algn="just" fontAlgn="base">
              <a:defRPr sz="94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defRPr>
            </a:lvl1pPr>
          </a:lstStyle>
          <a:p>
            <a:r>
              <a:rPr lang="en-US" sz="1100" b="1" dirty="0"/>
              <a:t> </a:t>
            </a:r>
            <a:endParaRPr lang="fr-FR" sz="1100" b="1" dirty="0"/>
          </a:p>
          <a:p>
            <a:r>
              <a:rPr lang="en-US" sz="1100" b="1" dirty="0"/>
              <a:t>Supplemental Figure S2. Structural comparison of human TfR1, rhesus monkey TfR1 and mouse TfR1 predicted targeted region. </a:t>
            </a:r>
            <a:endParaRPr lang="fr-FR" sz="1100" b="1" dirty="0"/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45B9E39A-EB76-AEB5-339F-691D05712973}"/>
              </a:ext>
            </a:extLst>
          </p:cNvPr>
          <p:cNvSpPr txBox="1"/>
          <p:nvPr/>
        </p:nvSpPr>
        <p:spPr>
          <a:xfrm>
            <a:off x="379298" y="250203"/>
            <a:ext cx="3150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/>
              <a:t>A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CFE1B249-5FCD-086C-BF7D-99B49BEBC76A}"/>
              </a:ext>
            </a:extLst>
          </p:cNvPr>
          <p:cNvSpPr txBox="1"/>
          <p:nvPr/>
        </p:nvSpPr>
        <p:spPr>
          <a:xfrm>
            <a:off x="399371" y="4048759"/>
            <a:ext cx="3150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/>
              <a:t>B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D943D9AB-6BE1-D9B2-E995-F5F8C6FB80FC}"/>
              </a:ext>
            </a:extLst>
          </p:cNvPr>
          <p:cNvSpPr txBox="1"/>
          <p:nvPr/>
        </p:nvSpPr>
        <p:spPr>
          <a:xfrm>
            <a:off x="3701552" y="279677"/>
            <a:ext cx="3150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/>
              <a:t>C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58EF06E6-DC59-48F2-4C5A-47E148F32A7D}"/>
              </a:ext>
            </a:extLst>
          </p:cNvPr>
          <p:cNvSpPr txBox="1"/>
          <p:nvPr/>
        </p:nvSpPr>
        <p:spPr>
          <a:xfrm>
            <a:off x="3701552" y="3845116"/>
            <a:ext cx="3150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0176468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>
            <a:extLst>
              <a:ext uri="{FF2B5EF4-FFF2-40B4-BE49-F238E27FC236}">
                <a16:creationId xmlns:a16="http://schemas.microsoft.com/office/drawing/2014/main" id="{FBA0EB02-82BA-F1B8-803F-1E5E732F2364}"/>
              </a:ext>
            </a:extLst>
          </p:cNvPr>
          <p:cNvSpPr txBox="1"/>
          <p:nvPr/>
        </p:nvSpPr>
        <p:spPr>
          <a:xfrm>
            <a:off x="1157078" y="6033192"/>
            <a:ext cx="290797" cy="291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92" b="1"/>
              <a:t>C</a:t>
            </a:r>
          </a:p>
        </p:txBody>
      </p:sp>
      <p:graphicFrame>
        <p:nvGraphicFramePr>
          <p:cNvPr id="5" name="Objet 4">
            <a:extLst>
              <a:ext uri="{FF2B5EF4-FFF2-40B4-BE49-F238E27FC236}">
                <a16:creationId xmlns:a16="http://schemas.microsoft.com/office/drawing/2014/main" id="{B34A5DD2-7134-025D-5EDF-10EA92FABB0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5843488"/>
              </p:ext>
            </p:extLst>
          </p:nvPr>
        </p:nvGraphicFramePr>
        <p:xfrm>
          <a:off x="1042988" y="6059488"/>
          <a:ext cx="4979987" cy="2152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" name="Prism 5" r:id="rId3" imgW="9565300" imgH="4139207" progId="Prism5.Document">
                  <p:embed/>
                </p:oleObj>
              </mc:Choice>
              <mc:Fallback>
                <p:oleObj name="Prism 5" r:id="rId3" imgW="9565300" imgH="4139207" progId="Prism5.Document">
                  <p:embed/>
                  <p:pic>
                    <p:nvPicPr>
                      <p:cNvPr id="5" name="Objet 4">
                        <a:extLst>
                          <a:ext uri="{FF2B5EF4-FFF2-40B4-BE49-F238E27FC236}">
                            <a16:creationId xmlns:a16="http://schemas.microsoft.com/office/drawing/2014/main" id="{B34A5DD2-7134-025D-5EDF-10EA92FABB0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42988" y="6059488"/>
                        <a:ext cx="4979987" cy="2152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ZoneTexte 7">
            <a:extLst>
              <a:ext uri="{FF2B5EF4-FFF2-40B4-BE49-F238E27FC236}">
                <a16:creationId xmlns:a16="http://schemas.microsoft.com/office/drawing/2014/main" id="{4CDD1617-CADC-BF13-5F09-8FE96FC66F1B}"/>
              </a:ext>
            </a:extLst>
          </p:cNvPr>
          <p:cNvSpPr txBox="1"/>
          <p:nvPr/>
        </p:nvSpPr>
        <p:spPr>
          <a:xfrm>
            <a:off x="948632" y="8267635"/>
            <a:ext cx="5342138" cy="553998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1000" b="1"/>
              <a:t>Supplemental Figure S3. </a:t>
            </a:r>
            <a:endParaRPr lang="en-US"/>
          </a:p>
          <a:p>
            <a:r>
              <a:rPr lang="en-US" sz="1000" b="1"/>
              <a:t>Binding of VHH-</a:t>
            </a:r>
            <a:r>
              <a:rPr lang="en-US" sz="1000" b="1" err="1"/>
              <a:t>hFc</a:t>
            </a:r>
            <a:r>
              <a:rPr lang="en-US" sz="1000" b="1"/>
              <a:t>* on mouse, rat and human brain endothelial cells.</a:t>
            </a:r>
            <a:endParaRPr lang="en-US" sz="1000" b="1">
              <a:cs typeface="Calibri"/>
            </a:endParaRPr>
          </a:p>
          <a:p>
            <a:endParaRPr lang="en-US" sz="1000"/>
          </a:p>
        </p:txBody>
      </p:sp>
      <p:pic>
        <p:nvPicPr>
          <p:cNvPr id="30" name="Image 29">
            <a:extLst>
              <a:ext uri="{FF2B5EF4-FFF2-40B4-BE49-F238E27FC236}">
                <a16:creationId xmlns:a16="http://schemas.microsoft.com/office/drawing/2014/main" id="{75C561A8-4014-3ADE-36E2-318D6CA40FB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40261" y="386876"/>
            <a:ext cx="3377477" cy="50784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66150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BACCDFC5-229D-4DD6-A195-33E25107DE50}"/>
              </a:ext>
            </a:extLst>
          </p:cNvPr>
          <p:cNvSpPr txBox="1"/>
          <p:nvPr/>
        </p:nvSpPr>
        <p:spPr>
          <a:xfrm>
            <a:off x="685627" y="8360234"/>
            <a:ext cx="5318191" cy="43088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 fontAlgn="base"/>
            <a:r>
              <a:rPr lang="fr-FR" sz="1100" b="1" err="1"/>
              <a:t>Supplemental</a:t>
            </a:r>
            <a:r>
              <a:rPr lang="fr-FR" sz="1100" b="1"/>
              <a:t> Figure S4. </a:t>
            </a:r>
            <a:r>
              <a:rPr lang="en-US" sz="1100" b="1"/>
              <a:t>Characterization of VHH-NT(8-13) binding to mFc-hTfR1 (</a:t>
            </a:r>
            <a:r>
              <a:rPr lang="en-US" sz="1100" b="1" err="1"/>
              <a:t>hTfR</a:t>
            </a:r>
            <a:r>
              <a:rPr lang="en-US" sz="1100" b="1"/>
              <a:t>) by SPR</a:t>
            </a:r>
            <a:endParaRPr lang="fr-FR" sz="1100"/>
          </a:p>
        </p:txBody>
      </p:sp>
      <p:pic>
        <p:nvPicPr>
          <p:cNvPr id="17" name="Image 16">
            <a:extLst>
              <a:ext uri="{FF2B5EF4-FFF2-40B4-BE49-F238E27FC236}">
                <a16:creationId xmlns:a16="http://schemas.microsoft.com/office/drawing/2014/main" id="{3DDBE091-645E-2858-0F6F-61276AB5F4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322" y="462958"/>
            <a:ext cx="6401355" cy="77913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2333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ZoneTexte 16">
            <a:extLst>
              <a:ext uri="{FF2B5EF4-FFF2-40B4-BE49-F238E27FC236}">
                <a16:creationId xmlns:a16="http://schemas.microsoft.com/office/drawing/2014/main" id="{BACCDFC5-229D-4DD6-A195-33E25107DE50}"/>
              </a:ext>
            </a:extLst>
          </p:cNvPr>
          <p:cNvSpPr txBox="1"/>
          <p:nvPr/>
        </p:nvSpPr>
        <p:spPr>
          <a:xfrm>
            <a:off x="569882" y="8374939"/>
            <a:ext cx="5318191" cy="43088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 fontAlgn="base"/>
            <a:r>
              <a:rPr lang="fr-FR" sz="1100" b="1" err="1"/>
              <a:t>Supplemental</a:t>
            </a:r>
            <a:r>
              <a:rPr lang="fr-FR" sz="1100" b="1"/>
              <a:t> Figure S5. </a:t>
            </a:r>
            <a:r>
              <a:rPr lang="en-US" sz="1100" b="1"/>
              <a:t>Characterization of VHH-NT(8-13) binding to mFc-rhTfR1 (</a:t>
            </a:r>
            <a:r>
              <a:rPr lang="en-US" sz="1100" b="1" err="1"/>
              <a:t>rhTfR</a:t>
            </a:r>
            <a:r>
              <a:rPr lang="en-US" sz="1100" b="1"/>
              <a:t>) by SPR</a:t>
            </a:r>
            <a:endParaRPr lang="fr-FR" sz="1100"/>
          </a:p>
        </p:txBody>
      </p:sp>
      <p:pic>
        <p:nvPicPr>
          <p:cNvPr id="31" name="Image 30">
            <a:extLst>
              <a:ext uri="{FF2B5EF4-FFF2-40B4-BE49-F238E27FC236}">
                <a16:creationId xmlns:a16="http://schemas.microsoft.com/office/drawing/2014/main" id="{5A454F56-3245-57A8-D214-2C592FB2A4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3081" y="383719"/>
            <a:ext cx="6431837" cy="75840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9357879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23b7771a-c72b-43f5-b1b6-600858b93876">
      <Terms xmlns="http://schemas.microsoft.com/office/infopath/2007/PartnerControls"/>
    </lcf76f155ced4ddcb4097134ff3c332f>
    <TaxCatchAll xmlns="957b3af8-5ae4-423f-8ff6-3a5e3b8072b6" xsi:nil="true"/>
    <SharedWithUsers xmlns="957b3af8-5ae4-423f-8ff6-3a5e3b8072b6">
      <UserInfo>
        <DisplayName>Diane BEUZELIN</DisplayName>
        <AccountId>91</AccountId>
        <AccountType/>
      </UserInfo>
    </SharedWithUsers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B71A2D455215D4C959A7A89C1D12967" ma:contentTypeVersion="17" ma:contentTypeDescription="Crée un document." ma:contentTypeScope="" ma:versionID="008f79c3ae36dcbdd469887c21cafb27">
  <xsd:schema xmlns:xsd="http://www.w3.org/2001/XMLSchema" xmlns:xs="http://www.w3.org/2001/XMLSchema" xmlns:p="http://schemas.microsoft.com/office/2006/metadata/properties" xmlns:ns2="23b7771a-c72b-43f5-b1b6-600858b93876" xmlns:ns3="957b3af8-5ae4-423f-8ff6-3a5e3b8072b6" targetNamespace="http://schemas.microsoft.com/office/2006/metadata/properties" ma:root="true" ma:fieldsID="61d59956e1e15b5ada514f35e705630e" ns2:_="" ns3:_="">
    <xsd:import namespace="23b7771a-c72b-43f5-b1b6-600858b93876"/>
    <xsd:import namespace="957b3af8-5ae4-423f-8ff6-3a5e3b8072b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ServiceOCR" minOccurs="0"/>
                <xsd:element ref="ns2:MediaServiceLocation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3b7771a-c72b-43f5-b1b6-600858b9387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9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1" nillable="true" ma:taxonomy="true" ma:internalName="lcf76f155ced4ddcb4097134ff3c332f" ma:taxonomyFieldName="MediaServiceImageTags" ma:displayName="Balises d’images" ma:readOnly="false" ma:fieldId="{5cf76f15-5ced-4ddc-b409-7134ff3c332f}" ma:taxonomyMulti="true" ma:sspId="fa8414ea-c021-4099-b8bf-2e07b67e2c6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57b3af8-5ae4-423f-8ff6-3a5e3b8072b6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7c485d7d-5598-4ed9-8b98-b98c360a8ae6}" ma:internalName="TaxCatchAll" ma:showField="CatchAllData" ma:web="957b3af8-5ae4-423f-8ff6-3a5e3b8072b6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7A920231-18C6-4E7E-9E14-E997FD17DEDE}">
  <ds:schemaRefs>
    <ds:schemaRef ds:uri="23b7771a-c72b-43f5-b1b6-600858b93876"/>
    <ds:schemaRef ds:uri="957b3af8-5ae4-423f-8ff6-3a5e3b8072b6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A9EE9E43-1884-4375-8C1F-38C8117C7CA1}">
  <ds:schemaRefs>
    <ds:schemaRef ds:uri="23b7771a-c72b-43f5-b1b6-600858b93876"/>
    <ds:schemaRef ds:uri="957b3af8-5ae4-423f-8ff6-3a5e3b8072b6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73932B09-B6B3-44C1-96A6-0CC112860C24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20</Words>
  <Application>Microsoft Macintosh PowerPoint</Application>
  <PresentationFormat>Affichage à l'écran (4:3)</PresentationFormat>
  <Paragraphs>19</Paragraphs>
  <Slides>5</Slides>
  <Notes>1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hème Office</vt:lpstr>
      <vt:lpstr>Prism 5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omy</dc:creator>
  <cp:lastModifiedBy>KHRESTCHATISKY Michel</cp:lastModifiedBy>
  <cp:revision>3</cp:revision>
  <cp:lastPrinted>2025-04-30T15:36:01Z</cp:lastPrinted>
  <dcterms:created xsi:type="dcterms:W3CDTF">2017-11-03T09:24:55Z</dcterms:created>
  <dcterms:modified xsi:type="dcterms:W3CDTF">2025-05-23T08:15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B71A2D455215D4C959A7A89C1D12967</vt:lpwstr>
  </property>
  <property fmtid="{D5CDD505-2E9C-101B-9397-08002B2CF9AE}" pid="3" name="MediaServiceImageTags">
    <vt:lpwstr/>
  </property>
</Properties>
</file>